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5"/>
  </p:notesMasterIdLst>
  <p:sldIdLst>
    <p:sldId id="284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5" r:id="rId30"/>
    <p:sldId id="286" r:id="rId31"/>
    <p:sldId id="287" r:id="rId32"/>
    <p:sldId id="288" r:id="rId33"/>
    <p:sldId id="289" r:id="rId3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603" autoAdjust="0"/>
    <p:restoredTop sz="94660"/>
  </p:normalViewPr>
  <p:slideViewPr>
    <p:cSldViewPr snapToGrid="0">
      <p:cViewPr varScale="1">
        <p:scale>
          <a:sx n="54" d="100"/>
          <a:sy n="54" d="100"/>
        </p:scale>
        <p:origin x="8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A2A7B3-C9D4-49E2-A714-B48BED5929F1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7A4D05-A7D4-4948-98B9-8F643D9B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0461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E" dirty="0"/>
              <a:t>Len’s new supplemental dat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27EF10-EB9E-884D-8F9E-CE88F19881DB}" type="slidenum">
              <a:rPr lang="en-IE" smtClean="0"/>
              <a:t>5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06320368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E" dirty="0"/>
              <a:t>New legen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27EF10-EB9E-884D-8F9E-CE88F19881DB}" type="slidenum">
              <a:rPr lang="en-IE" smtClean="0"/>
              <a:t>6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733293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6422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9590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7200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2960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171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0169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0754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4828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7599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0031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1299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14E096-E540-4857-9AF5-FC90DDD47FD9}" type="datetimeFigureOut">
              <a:rPr lang="en-GB" smtClean="0"/>
              <a:t>07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DA8AB6-290F-49EF-BC21-C8EDF6B5F0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9228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6.em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0.emf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FC89CCF-F888-3449-B897-8060E2897151}"/>
              </a:ext>
            </a:extLst>
          </p:cNvPr>
          <p:cNvSpPr txBox="1"/>
          <p:nvPr/>
        </p:nvSpPr>
        <p:spPr>
          <a:xfrm>
            <a:off x="1110343" y="770708"/>
            <a:ext cx="455490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Supplemental information</a:t>
            </a:r>
          </a:p>
        </p:txBody>
      </p:sp>
    </p:spTree>
    <p:extLst>
      <p:ext uri="{BB962C8B-B14F-4D97-AF65-F5344CB8AC3E}">
        <p14:creationId xmlns:p14="http://schemas.microsoft.com/office/powerpoint/2010/main" val="10207786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9088CAC-6B1E-4547-AAEE-702A6AB9CB31}"/>
              </a:ext>
            </a:extLst>
          </p:cNvPr>
          <p:cNvSpPr/>
          <p:nvPr/>
        </p:nvSpPr>
        <p:spPr>
          <a:xfrm>
            <a:off x="1454727" y="1680092"/>
            <a:ext cx="9125528" cy="18269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</a:t>
            </a:r>
            <a:r>
              <a:rPr lang="en-GB" sz="20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ting strategy for T cell subsets.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+ and CD8+ subsets were gated as shown previously. CD4+ T cells are shown in the left hand column and CD8+ T cells on the right. Treg were gated within the CD4+ population as CD25+CD127low cells. Activated T cells were gated as CD38+HLA-DR+ as shown.</a:t>
            </a:r>
          </a:p>
        </p:txBody>
      </p:sp>
    </p:spTree>
    <p:extLst>
      <p:ext uri="{BB962C8B-B14F-4D97-AF65-F5344CB8AC3E}">
        <p14:creationId xmlns:p14="http://schemas.microsoft.com/office/powerpoint/2010/main" val="107794588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3505398" y="263236"/>
          <a:ext cx="4696492" cy="64700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9" r:id="rId3" imgW="4585968" imgH="6318182" progId="Prism9.Document">
                  <p:embed/>
                </p:oleObj>
              </mc:Choice>
              <mc:Fallback>
                <p:oleObj name="Prism 9" r:id="rId3" imgW="4585968" imgH="6318182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05398" y="263236"/>
                        <a:ext cx="4696492" cy="64700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9A1DF1B2-D720-0345-BAFF-930ED9C73B00}"/>
              </a:ext>
            </a:extLst>
          </p:cNvPr>
          <p:cNvSpPr/>
          <p:nvPr/>
        </p:nvSpPr>
        <p:spPr>
          <a:xfrm>
            <a:off x="318660" y="263236"/>
            <a:ext cx="10653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8377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82CB347-33AC-7B4A-B40C-116184F192E6}"/>
              </a:ext>
            </a:extLst>
          </p:cNvPr>
          <p:cNvSpPr/>
          <p:nvPr/>
        </p:nvSpPr>
        <p:spPr>
          <a:xfrm>
            <a:off x="1066800" y="1009430"/>
            <a:ext cx="10510309" cy="32467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20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C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ting strategy for B cells and monocytes. 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GB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ter exclusion of debris and doublets CD45+ cells were selected and subdivided into lymphocytes, monocytes and granulocytes according to CD45 expression level and side scatter properties. Within the lymphocyte gate B cells were selected as CD19+ and antibody secreting cells identified as CD27+CD38+. Lineage negative monocytes (CD3 / CD19 / CD66b / CD56-)were subdivided to classical, transitional and non-classical subsets according to expression of CD14 and CD16. A control non-</a:t>
            </a:r>
            <a:r>
              <a:rPr lang="en-GB" sz="20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vid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ample showing a distinct non-classical monocyte population is also shown. Granulocytes were subdivided into Neutrophils and Eosinophils on the basis of CD16 expression.</a:t>
            </a:r>
          </a:p>
        </p:txBody>
      </p:sp>
    </p:spTree>
    <p:extLst>
      <p:ext uri="{BB962C8B-B14F-4D97-AF65-F5344CB8AC3E}">
        <p14:creationId xmlns:p14="http://schemas.microsoft.com/office/powerpoint/2010/main" val="286028325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64D87B3-1167-A94B-A59F-8DD7F04504CC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766"/>
          <a:stretch/>
        </p:blipFill>
        <p:spPr>
          <a:xfrm>
            <a:off x="2686260" y="124691"/>
            <a:ext cx="5848139" cy="67333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EE453AB-4ACA-A944-A423-2CE74120103A}"/>
              </a:ext>
            </a:extLst>
          </p:cNvPr>
          <p:cNvSpPr txBox="1"/>
          <p:nvPr/>
        </p:nvSpPr>
        <p:spPr>
          <a:xfrm>
            <a:off x="8368145" y="1066800"/>
            <a:ext cx="869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/>
              <a:t>Panel 4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A1DF1B2-D720-0345-BAFF-930ED9C73B00}"/>
              </a:ext>
            </a:extLst>
          </p:cNvPr>
          <p:cNvSpPr/>
          <p:nvPr/>
        </p:nvSpPr>
        <p:spPr>
          <a:xfrm>
            <a:off x="318660" y="263236"/>
            <a:ext cx="10894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951702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683482E-1516-994A-810D-9B91264D6589}"/>
              </a:ext>
            </a:extLst>
          </p:cNvPr>
          <p:cNvSpPr/>
          <p:nvPr/>
        </p:nvSpPr>
        <p:spPr>
          <a:xfrm>
            <a:off x="1600968" y="1067940"/>
            <a:ext cx="7584596" cy="19295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20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D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ting strategy for monocyte chemokine receptors. 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GB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ter exclusion of debris, CD45- events and doublets lineage negative (CD3/CD19/CD56/CD66b-) monocytes were gated for measurement of chemokine receptor expression.</a:t>
            </a:r>
          </a:p>
        </p:txBody>
      </p:sp>
    </p:spTree>
    <p:extLst>
      <p:ext uri="{BB962C8B-B14F-4D97-AF65-F5344CB8AC3E}">
        <p14:creationId xmlns:p14="http://schemas.microsoft.com/office/powerpoint/2010/main" val="278509700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E20CC4B-327E-0446-9CE4-302DCB88E5DD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1636"/>
          <a:stretch/>
        </p:blipFill>
        <p:spPr>
          <a:xfrm>
            <a:off x="2031431" y="706582"/>
            <a:ext cx="8844387" cy="5209309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587DB9BE-B669-6742-8ADB-6B75922C7C10}"/>
              </a:ext>
            </a:extLst>
          </p:cNvPr>
          <p:cNvSpPr/>
          <p:nvPr/>
        </p:nvSpPr>
        <p:spPr>
          <a:xfrm>
            <a:off x="176324" y="337250"/>
            <a:ext cx="105573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373809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hape, arrow&#10;&#10;Description automatically generated">
            <a:extLst>
              <a:ext uri="{FF2B5EF4-FFF2-40B4-BE49-F238E27FC236}">
                <a16:creationId xmlns:a16="http://schemas.microsoft.com/office/drawing/2014/main" id="{8CA90BF5-D0C3-5F4B-BAD9-118BD9E1B0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2525" y="1080656"/>
            <a:ext cx="9372192" cy="44611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147146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F55AC17-9573-544A-840E-E90B54D54038}"/>
              </a:ext>
            </a:extLst>
          </p:cNvPr>
          <p:cNvSpPr/>
          <p:nvPr/>
        </p:nvSpPr>
        <p:spPr>
          <a:xfrm>
            <a:off x="2162849" y="1476977"/>
            <a:ext cx="7244387" cy="18269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20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E</a:t>
            </a: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ting strategy for neutrophils. 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ter exclusion of debris and doublets SSC-H high, lineage negative (CD3/CD19/CD56/Siglec-8) events were gated and CD15+CD66b+ cells selected as neutrophils. Immature neutrophils were gated as CD10 low. </a:t>
            </a:r>
          </a:p>
        </p:txBody>
      </p:sp>
    </p:spTree>
    <p:extLst>
      <p:ext uri="{BB962C8B-B14F-4D97-AF65-F5344CB8AC3E}">
        <p14:creationId xmlns:p14="http://schemas.microsoft.com/office/powerpoint/2010/main" val="349658609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D88F5BA-3FE5-4C45-A08E-04B227584418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904489" y="328681"/>
          <a:ext cx="10383022" cy="6467920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1869272">
                  <a:extLst>
                    <a:ext uri="{9D8B030D-6E8A-4147-A177-3AD203B41FA5}">
                      <a16:colId xmlns:a16="http://schemas.microsoft.com/office/drawing/2014/main" val="3079278982"/>
                    </a:ext>
                  </a:extLst>
                </a:gridCol>
                <a:gridCol w="1946670">
                  <a:extLst>
                    <a:ext uri="{9D8B030D-6E8A-4147-A177-3AD203B41FA5}">
                      <a16:colId xmlns:a16="http://schemas.microsoft.com/office/drawing/2014/main" val="3243192132"/>
                    </a:ext>
                  </a:extLst>
                </a:gridCol>
                <a:gridCol w="1876308">
                  <a:extLst>
                    <a:ext uri="{9D8B030D-6E8A-4147-A177-3AD203B41FA5}">
                      <a16:colId xmlns:a16="http://schemas.microsoft.com/office/drawing/2014/main" val="1333833356"/>
                    </a:ext>
                  </a:extLst>
                </a:gridCol>
                <a:gridCol w="1266509">
                  <a:extLst>
                    <a:ext uri="{9D8B030D-6E8A-4147-A177-3AD203B41FA5}">
                      <a16:colId xmlns:a16="http://schemas.microsoft.com/office/drawing/2014/main" val="2944168427"/>
                    </a:ext>
                  </a:extLst>
                </a:gridCol>
                <a:gridCol w="1383777">
                  <a:extLst>
                    <a:ext uri="{9D8B030D-6E8A-4147-A177-3AD203B41FA5}">
                      <a16:colId xmlns:a16="http://schemas.microsoft.com/office/drawing/2014/main" val="3699268493"/>
                    </a:ext>
                  </a:extLst>
                </a:gridCol>
                <a:gridCol w="2040486">
                  <a:extLst>
                    <a:ext uri="{9D8B030D-6E8A-4147-A177-3AD203B41FA5}">
                      <a16:colId xmlns:a16="http://schemas.microsoft.com/office/drawing/2014/main" val="2099890063"/>
                    </a:ext>
                  </a:extLst>
                </a:gridCol>
              </a:tblGrid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Target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Flourophor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lon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Isotyp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Supplier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Cat number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19408819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F70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UCHT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042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85985450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71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OKT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b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1744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35715651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CD8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42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RPA-T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103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06051894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5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60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QA17A0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9330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81474829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45R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FITC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I10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b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414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59266323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CCR7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-Dazzl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GO43H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5323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75738401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XCR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GO25H7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5370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38263759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CR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rCP-Cy5.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G034E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b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5340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93576572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10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APC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erACT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5021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41942549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5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PC-cy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CD5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1833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973764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45RO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rCP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UCHL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425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65556843"/>
                  </a:ext>
                </a:extLst>
              </a:tr>
              <a:tr h="46671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TCR gamma delt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51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3122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64095292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3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FITC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IT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350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513889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LA-DR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PC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L24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761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04680489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39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60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2823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77562684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D-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EH12.2H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2990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56280700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2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65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V T0-7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b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263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11522218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12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rCP-cy5.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019D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5132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79738619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Tim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Dazzl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F38-2E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354034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02723646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CD45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err="1">
                          <a:effectLst/>
                        </a:rPr>
                        <a:t>PerCP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2D1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err="1">
                          <a:effectLst/>
                        </a:rPr>
                        <a:t>ms</a:t>
                      </a:r>
                      <a:r>
                        <a:rPr lang="en-GB" sz="1600" dirty="0">
                          <a:effectLst/>
                        </a:rPr>
                        <a:t> IgG1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 err="1">
                          <a:effectLst/>
                        </a:rPr>
                        <a:t>Biolegend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368506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80943807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CD3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F70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SK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4482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544580174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19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-dazzl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IB19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225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3976082718"/>
                  </a:ext>
                </a:extLst>
              </a:tr>
              <a:tr h="22807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5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PC-cy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CD5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318332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79973708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F3E66012-9397-3D44-A911-BFA1CE4DABCB}"/>
              </a:ext>
            </a:extLst>
          </p:cNvPr>
          <p:cNvSpPr/>
          <p:nvPr/>
        </p:nvSpPr>
        <p:spPr>
          <a:xfrm>
            <a:off x="0" y="0"/>
            <a:ext cx="8597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475435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6999CED-CD93-EE44-8FBC-C10B337EF981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071587" y="135366"/>
          <a:ext cx="9734958" cy="6523050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1752600">
                  <a:extLst>
                    <a:ext uri="{9D8B030D-6E8A-4147-A177-3AD203B41FA5}">
                      <a16:colId xmlns:a16="http://schemas.microsoft.com/office/drawing/2014/main" val="3245045199"/>
                    </a:ext>
                  </a:extLst>
                </a:gridCol>
                <a:gridCol w="1825167">
                  <a:extLst>
                    <a:ext uri="{9D8B030D-6E8A-4147-A177-3AD203B41FA5}">
                      <a16:colId xmlns:a16="http://schemas.microsoft.com/office/drawing/2014/main" val="1235243983"/>
                    </a:ext>
                  </a:extLst>
                </a:gridCol>
                <a:gridCol w="1759198">
                  <a:extLst>
                    <a:ext uri="{9D8B030D-6E8A-4147-A177-3AD203B41FA5}">
                      <a16:colId xmlns:a16="http://schemas.microsoft.com/office/drawing/2014/main" val="134269044"/>
                    </a:ext>
                  </a:extLst>
                </a:gridCol>
                <a:gridCol w="1187457">
                  <a:extLst>
                    <a:ext uri="{9D8B030D-6E8A-4147-A177-3AD203B41FA5}">
                      <a16:colId xmlns:a16="http://schemas.microsoft.com/office/drawing/2014/main" val="2585857358"/>
                    </a:ext>
                  </a:extLst>
                </a:gridCol>
                <a:gridCol w="1297409">
                  <a:extLst>
                    <a:ext uri="{9D8B030D-6E8A-4147-A177-3AD203B41FA5}">
                      <a16:colId xmlns:a16="http://schemas.microsoft.com/office/drawing/2014/main" val="3293132355"/>
                    </a:ext>
                  </a:extLst>
                </a:gridCol>
                <a:gridCol w="1913127">
                  <a:extLst>
                    <a:ext uri="{9D8B030D-6E8A-4147-A177-3AD203B41FA5}">
                      <a16:colId xmlns:a16="http://schemas.microsoft.com/office/drawing/2014/main" val="172933338"/>
                    </a:ext>
                  </a:extLst>
                </a:gridCol>
              </a:tblGrid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Target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Flourophor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lon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Isotyp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Supplier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Cat number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18645800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1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71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63D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367140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110550341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1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42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VNK8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302038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286370426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LA-DR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PC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L24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307610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46176153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66b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QA17A5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9290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105643061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2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rCP-cy5.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-T27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5640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209624821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3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FITC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IT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350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277745787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27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65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29E.2A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b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329740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377418912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HLA-DR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65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L24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765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172883606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CR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rCPcy5.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K0363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5720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385838279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X3CR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-dazzl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2A9-1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rat igG2b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4162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283376699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CR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PC-cy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J418F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rat igG2b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5911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704132279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CD3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APC 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UCHT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041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19157790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19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PC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IB19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221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121468341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5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PC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CD5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1831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126624652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Siglec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PC 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7C9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4710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224411630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66b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6/40c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9290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349025954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1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PC-Cy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W6D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2304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342760377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11b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rCPcy5.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LM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9310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626162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62L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PE-Dazzle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DREG-5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484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645734309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64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71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10.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504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131872715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1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42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g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0203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77016552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1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V605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I10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1222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2403996455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54 (ICAM-1) 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F70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HA5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35312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180142883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CD181 (CXCR1)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AF488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8F1 CXCR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ms IgG2a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effectLst/>
                        </a:rPr>
                        <a:t>Biolegend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effectLst/>
                        </a:rPr>
                        <a:t>320616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018" marR="58018" marT="0" marB="0"/>
                </a:tc>
                <a:extLst>
                  <a:ext uri="{0D108BD9-81ED-4DB2-BD59-A6C34878D82A}">
                    <a16:rowId xmlns:a16="http://schemas.microsoft.com/office/drawing/2014/main" val="37436007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578659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/>
          </p:nvPr>
        </p:nvGraphicFramePr>
        <p:xfrm>
          <a:off x="1190057" y="1098810"/>
          <a:ext cx="9268692" cy="4281052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7748939">
                  <a:extLst>
                    <a:ext uri="{9D8B030D-6E8A-4147-A177-3AD203B41FA5}">
                      <a16:colId xmlns:a16="http://schemas.microsoft.com/office/drawing/2014/main" val="476064458"/>
                    </a:ext>
                  </a:extLst>
                </a:gridCol>
                <a:gridCol w="1519753">
                  <a:extLst>
                    <a:ext uri="{9D8B030D-6E8A-4147-A177-3AD203B41FA5}">
                      <a16:colId xmlns:a16="http://schemas.microsoft.com/office/drawing/2014/main" val="4226044763"/>
                    </a:ext>
                  </a:extLst>
                </a:gridCol>
              </a:tblGrid>
              <a:tr h="46720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Daily visits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Frequency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1917170064"/>
                  </a:ext>
                </a:extLst>
              </a:tr>
              <a:tr h="467209">
                <a:tc gridSpan="2"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Clinical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101430941"/>
                  </a:ext>
                </a:extLst>
              </a:tr>
              <a:tr h="46720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History and examination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Daily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717446095"/>
                  </a:ext>
                </a:extLst>
              </a:tr>
              <a:tr h="101058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Routine observations (heart rate, blood pressure, respiratory rate, temperature, oxygen saturations)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Daily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3697955142"/>
                  </a:ext>
                </a:extLst>
              </a:tr>
              <a:tr h="46720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Oxygen requirement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Daily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3160752882"/>
                  </a:ext>
                </a:extLst>
              </a:tr>
              <a:tr h="46720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Ventilatory support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Daily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1770474165"/>
                  </a:ext>
                </a:extLst>
              </a:tr>
              <a:tr h="46720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Renal replacement therapy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Daily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426176776"/>
                  </a:ext>
                </a:extLst>
              </a:tr>
              <a:tr h="46720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ECG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Daily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2021698416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40E85B90-5FD2-DB45-B260-C8EEB64ABDB0}"/>
              </a:ext>
            </a:extLst>
          </p:cNvPr>
          <p:cNvSpPr/>
          <p:nvPr/>
        </p:nvSpPr>
        <p:spPr>
          <a:xfrm>
            <a:off x="137697" y="154292"/>
            <a:ext cx="8597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ea typeface="Calibri" panose="020F0502020204030204" pitchFamily="34" charset="0"/>
                <a:cs typeface="Arial" panose="020B0604020202020204" pitchFamily="34" charset="0"/>
              </a:rPr>
              <a:t>Table 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346092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D4DD848-EB5A-0A48-BDA9-68A6C9BF73D8}"/>
              </a:ext>
            </a:extLst>
          </p:cNvPr>
          <p:cNvSpPr/>
          <p:nvPr/>
        </p:nvSpPr>
        <p:spPr>
          <a:xfrm>
            <a:off x="1734790" y="1218460"/>
            <a:ext cx="4734951" cy="4070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20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4: </a:t>
            </a:r>
            <a:r>
              <a:rPr lang="en-GB" sz="2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tibodies used for flow cytometry</a:t>
            </a:r>
          </a:p>
        </p:txBody>
      </p:sp>
    </p:spTree>
    <p:extLst>
      <p:ext uri="{BB962C8B-B14F-4D97-AF65-F5344CB8AC3E}">
        <p14:creationId xmlns:p14="http://schemas.microsoft.com/office/powerpoint/2010/main" val="388857916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5B05EBAF-F780-2D43-8746-137106A433D5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310777" y="540372"/>
          <a:ext cx="11217836" cy="608695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602548">
                  <a:extLst>
                    <a:ext uri="{9D8B030D-6E8A-4147-A177-3AD203B41FA5}">
                      <a16:colId xmlns:a16="http://schemas.microsoft.com/office/drawing/2014/main" val="272033461"/>
                    </a:ext>
                  </a:extLst>
                </a:gridCol>
                <a:gridCol w="1602548">
                  <a:extLst>
                    <a:ext uri="{9D8B030D-6E8A-4147-A177-3AD203B41FA5}">
                      <a16:colId xmlns:a16="http://schemas.microsoft.com/office/drawing/2014/main" val="1492794317"/>
                    </a:ext>
                  </a:extLst>
                </a:gridCol>
                <a:gridCol w="1602548">
                  <a:extLst>
                    <a:ext uri="{9D8B030D-6E8A-4147-A177-3AD203B41FA5}">
                      <a16:colId xmlns:a16="http://schemas.microsoft.com/office/drawing/2014/main" val="1440716106"/>
                    </a:ext>
                  </a:extLst>
                </a:gridCol>
                <a:gridCol w="1602548">
                  <a:extLst>
                    <a:ext uri="{9D8B030D-6E8A-4147-A177-3AD203B41FA5}">
                      <a16:colId xmlns:a16="http://schemas.microsoft.com/office/drawing/2014/main" val="1676567569"/>
                    </a:ext>
                  </a:extLst>
                </a:gridCol>
                <a:gridCol w="1602548">
                  <a:extLst>
                    <a:ext uri="{9D8B030D-6E8A-4147-A177-3AD203B41FA5}">
                      <a16:colId xmlns:a16="http://schemas.microsoft.com/office/drawing/2014/main" val="165867348"/>
                    </a:ext>
                  </a:extLst>
                </a:gridCol>
                <a:gridCol w="1602548">
                  <a:extLst>
                    <a:ext uri="{9D8B030D-6E8A-4147-A177-3AD203B41FA5}">
                      <a16:colId xmlns:a16="http://schemas.microsoft.com/office/drawing/2014/main" val="2908037369"/>
                    </a:ext>
                  </a:extLst>
                </a:gridCol>
                <a:gridCol w="1602548">
                  <a:extLst>
                    <a:ext uri="{9D8B030D-6E8A-4147-A177-3AD203B41FA5}">
                      <a16:colId xmlns:a16="http://schemas.microsoft.com/office/drawing/2014/main" val="372829654"/>
                    </a:ext>
                  </a:extLst>
                </a:gridCol>
              </a:tblGrid>
              <a:tr h="308261"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</a:rPr>
                        <a:t>Result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Ar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ea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SD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edia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i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</a:rPr>
                        <a:t>Max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7886178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Haemoglobin (g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27.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.4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26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8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57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41657344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44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1.9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44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22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67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99341273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Haematocrit (ratio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3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3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3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4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89358486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4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4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3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4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95014017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Red Cell Count (10^12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2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4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1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6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.2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9070354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 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7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3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8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8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.3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88734751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Mean cell volume (f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7.2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.3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9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3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2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23196578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NM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6.2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4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6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4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47485023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Mean cell Hb (</a:t>
                      </a:r>
                      <a:r>
                        <a:rPr lang="en-GB" sz="1200" dirty="0" err="1">
                          <a:effectLst/>
                        </a:rPr>
                        <a:t>pg</a:t>
                      </a:r>
                      <a:r>
                        <a:rPr lang="en-GB" sz="1200" dirty="0">
                          <a:effectLst/>
                        </a:rPr>
                        <a:t>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9.9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4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0.4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4.4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4.4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41050953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0.3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3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0.4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7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2.6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31002918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Mean cell Hb Conc (g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44.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2.4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44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17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99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22344058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52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.5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52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29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83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67544409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White cell count (10^9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.0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1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.0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6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2.8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19394704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2.2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9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1.1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8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6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37083206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Neutrophil count (10^9/L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SoC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7.51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3.33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7.26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2.12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18.93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45417673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5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.3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0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9.8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49842117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Lymphocytes (10^9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6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5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1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2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.5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59152538"/>
                  </a:ext>
                </a:extLst>
              </a:tr>
              <a:tr h="308261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 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1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6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9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2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2.99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0345352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82BADBC-9D20-0A49-8EC9-BF59C3D434F5}"/>
              </a:ext>
            </a:extLst>
          </p:cNvPr>
          <p:cNvSpPr txBox="1"/>
          <p:nvPr/>
        </p:nvSpPr>
        <p:spPr>
          <a:xfrm>
            <a:off x="304800" y="143435"/>
            <a:ext cx="859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Table</a:t>
            </a:r>
            <a:r>
              <a:rPr lang="en-IE" dirty="0"/>
              <a:t> </a:t>
            </a:r>
            <a:r>
              <a:rPr lang="en-IE" b="1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337502492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C4922EC6-F082-8B4B-A8B9-174F821D0858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15153" y="127995"/>
          <a:ext cx="11761694" cy="6515536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680242">
                  <a:extLst>
                    <a:ext uri="{9D8B030D-6E8A-4147-A177-3AD203B41FA5}">
                      <a16:colId xmlns:a16="http://schemas.microsoft.com/office/drawing/2014/main" val="1755639824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4210351086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1286153381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1460978306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1417104805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2949196870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4268143881"/>
                    </a:ext>
                  </a:extLst>
                </a:gridCol>
              </a:tblGrid>
              <a:tr h="338641"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</a:rPr>
                        <a:t>Result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Ar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ea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SD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edia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i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</a:rPr>
                        <a:t>Max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42706077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Monocyte count (10^9/L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7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3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7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1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7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10515437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8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5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7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2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5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75156765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Basophil count (10^9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1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20090997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4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4136858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Eosinophil count (10^9/L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2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9198995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2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68892269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Platelet count (10^9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95.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5.6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82.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31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55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19558428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01.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65.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65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2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00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4125991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Random Glucose (mmol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.8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6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.2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2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19.7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6961385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.1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4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.6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8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5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41909918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Urea (mmol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.1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3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.9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2.4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46451575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.2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0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.7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9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23.3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61862881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Sodium (mmol/L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38.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5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38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32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43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44946270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36.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6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37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17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45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31360600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Potassium (mmol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0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3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3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65055840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4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5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4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4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.9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77752393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Chloride (mmol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2.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7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2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2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8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92432479"/>
                  </a:ext>
                </a:extLst>
              </a:tr>
              <a:tr h="33864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2.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7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3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8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111.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62300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4077789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BEADE4AC-0E46-9049-8B31-CC2DB1572942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15153" y="127995"/>
          <a:ext cx="11833409" cy="6487949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690487">
                  <a:extLst>
                    <a:ext uri="{9D8B030D-6E8A-4147-A177-3AD203B41FA5}">
                      <a16:colId xmlns:a16="http://schemas.microsoft.com/office/drawing/2014/main" val="1755639824"/>
                    </a:ext>
                  </a:extLst>
                </a:gridCol>
                <a:gridCol w="1690487">
                  <a:extLst>
                    <a:ext uri="{9D8B030D-6E8A-4147-A177-3AD203B41FA5}">
                      <a16:colId xmlns:a16="http://schemas.microsoft.com/office/drawing/2014/main" val="4210351086"/>
                    </a:ext>
                  </a:extLst>
                </a:gridCol>
                <a:gridCol w="1690487">
                  <a:extLst>
                    <a:ext uri="{9D8B030D-6E8A-4147-A177-3AD203B41FA5}">
                      <a16:colId xmlns:a16="http://schemas.microsoft.com/office/drawing/2014/main" val="1286153381"/>
                    </a:ext>
                  </a:extLst>
                </a:gridCol>
                <a:gridCol w="1690487">
                  <a:extLst>
                    <a:ext uri="{9D8B030D-6E8A-4147-A177-3AD203B41FA5}">
                      <a16:colId xmlns:a16="http://schemas.microsoft.com/office/drawing/2014/main" val="1460978306"/>
                    </a:ext>
                  </a:extLst>
                </a:gridCol>
                <a:gridCol w="1690487">
                  <a:extLst>
                    <a:ext uri="{9D8B030D-6E8A-4147-A177-3AD203B41FA5}">
                      <a16:colId xmlns:a16="http://schemas.microsoft.com/office/drawing/2014/main" val="1417104805"/>
                    </a:ext>
                  </a:extLst>
                </a:gridCol>
                <a:gridCol w="1690487">
                  <a:extLst>
                    <a:ext uri="{9D8B030D-6E8A-4147-A177-3AD203B41FA5}">
                      <a16:colId xmlns:a16="http://schemas.microsoft.com/office/drawing/2014/main" val="2949196870"/>
                    </a:ext>
                  </a:extLst>
                </a:gridCol>
                <a:gridCol w="1690487">
                  <a:extLst>
                    <a:ext uri="{9D8B030D-6E8A-4147-A177-3AD203B41FA5}">
                      <a16:colId xmlns:a16="http://schemas.microsoft.com/office/drawing/2014/main" val="4268143881"/>
                    </a:ext>
                  </a:extLst>
                </a:gridCol>
              </a:tblGrid>
              <a:tr h="341471"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</a:rPr>
                        <a:t>Result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Ar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ea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SD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edia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i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</a:rPr>
                        <a:t>Max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42706077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Magnesium (mmol/L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8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0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8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6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0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10515437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8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8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6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0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75156765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Bicarbonate (mmol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5.0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4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5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20090997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2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5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2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6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4136858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Creatinine (micromole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9.3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.8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7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3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11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9198995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2.5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2.0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5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4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76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68892269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Total protein (g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1.4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.5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7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19558428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2.3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.2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3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3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4125991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Albumin (g/L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8.2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4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8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3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5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6961385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9.7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6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8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41909918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AST (U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6.1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5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7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82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46451575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3.1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3.6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2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2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28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61862881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Bilirubin (micromole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.5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7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7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44946270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1.6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.0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39.0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31360600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GGT (U/L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1.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1.1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5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28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65055840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6.7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0.0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4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24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77752393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ALT (U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5.7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6.9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4.5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325.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92432479"/>
                  </a:ext>
                </a:extLst>
              </a:tr>
              <a:tr h="341471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2.5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7.7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4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3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304.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62300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1585466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802192B2-CDAB-B043-B443-ED179C122B36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43436" y="199714"/>
          <a:ext cx="11851343" cy="643416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693049">
                  <a:extLst>
                    <a:ext uri="{9D8B030D-6E8A-4147-A177-3AD203B41FA5}">
                      <a16:colId xmlns:a16="http://schemas.microsoft.com/office/drawing/2014/main" val="511665144"/>
                    </a:ext>
                  </a:extLst>
                </a:gridCol>
                <a:gridCol w="1693049">
                  <a:extLst>
                    <a:ext uri="{9D8B030D-6E8A-4147-A177-3AD203B41FA5}">
                      <a16:colId xmlns:a16="http://schemas.microsoft.com/office/drawing/2014/main" val="3729448617"/>
                    </a:ext>
                  </a:extLst>
                </a:gridCol>
                <a:gridCol w="1693049">
                  <a:extLst>
                    <a:ext uri="{9D8B030D-6E8A-4147-A177-3AD203B41FA5}">
                      <a16:colId xmlns:a16="http://schemas.microsoft.com/office/drawing/2014/main" val="2866999305"/>
                    </a:ext>
                  </a:extLst>
                </a:gridCol>
                <a:gridCol w="1693049">
                  <a:extLst>
                    <a:ext uri="{9D8B030D-6E8A-4147-A177-3AD203B41FA5}">
                      <a16:colId xmlns:a16="http://schemas.microsoft.com/office/drawing/2014/main" val="2063323109"/>
                    </a:ext>
                  </a:extLst>
                </a:gridCol>
                <a:gridCol w="1693049">
                  <a:extLst>
                    <a:ext uri="{9D8B030D-6E8A-4147-A177-3AD203B41FA5}">
                      <a16:colId xmlns:a16="http://schemas.microsoft.com/office/drawing/2014/main" val="3761039076"/>
                    </a:ext>
                  </a:extLst>
                </a:gridCol>
                <a:gridCol w="1693049">
                  <a:extLst>
                    <a:ext uri="{9D8B030D-6E8A-4147-A177-3AD203B41FA5}">
                      <a16:colId xmlns:a16="http://schemas.microsoft.com/office/drawing/2014/main" val="2246339493"/>
                    </a:ext>
                  </a:extLst>
                </a:gridCol>
                <a:gridCol w="1693049">
                  <a:extLst>
                    <a:ext uri="{9D8B030D-6E8A-4147-A177-3AD203B41FA5}">
                      <a16:colId xmlns:a16="http://schemas.microsoft.com/office/drawing/2014/main" val="614297488"/>
                    </a:ext>
                  </a:extLst>
                </a:gridCol>
              </a:tblGrid>
              <a:tr h="338640"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</a:rPr>
                        <a:t>Result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Ar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ea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SD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edia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i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</a:rPr>
                        <a:t>Max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84289787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 dirty="0" err="1">
                          <a:effectLst/>
                        </a:rPr>
                        <a:t>Alk</a:t>
                      </a:r>
                      <a:r>
                        <a:rPr lang="en-GB" sz="1200" dirty="0">
                          <a:effectLst/>
                        </a:rPr>
                        <a:t> </a:t>
                      </a:r>
                      <a:r>
                        <a:rPr lang="en-GB" sz="1200" dirty="0" err="1">
                          <a:effectLst/>
                        </a:rPr>
                        <a:t>Phos</a:t>
                      </a:r>
                      <a:r>
                        <a:rPr lang="en-GB" sz="1200" dirty="0">
                          <a:effectLst/>
                        </a:rPr>
                        <a:t> (U/L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 err="1">
                          <a:effectLst/>
                        </a:rPr>
                        <a:t>SoC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8.5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3.3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8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7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67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29002415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NM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81.08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4.4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7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6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42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33854173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LDH (U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SoC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348.7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33.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19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81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13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89899476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427.5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110.7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28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00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75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95860385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Ferritin (micromol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43.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766.9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78.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5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15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87569601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918.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16.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44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13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83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60885470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CRP (mg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9.5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48.07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3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35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30953980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 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4.6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1.7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17.0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14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93729103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Troponin (ng/L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.2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.1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7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41179549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8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.9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2.5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4266266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Triglycerides (mmol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0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0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8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0.8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6.7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63559284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 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7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8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6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0.5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.2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92962939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D-Dimer (ng/m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27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326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49.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149.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6900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42615148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24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25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21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50.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12443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0397849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Creatine kinase (U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10.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52.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9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7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1677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73514393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4.6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28.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9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108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94056639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INR (ratio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1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8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1.7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13959676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0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2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9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2.0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341687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8638306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00DBD272-CAE1-214A-A751-6F78B4DCA157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15153" y="217643"/>
          <a:ext cx="11761694" cy="407924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680242">
                  <a:extLst>
                    <a:ext uri="{9D8B030D-6E8A-4147-A177-3AD203B41FA5}">
                      <a16:colId xmlns:a16="http://schemas.microsoft.com/office/drawing/2014/main" val="511665144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3729448617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2866999305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2063323109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3761039076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2246339493"/>
                    </a:ext>
                  </a:extLst>
                </a:gridCol>
                <a:gridCol w="1680242">
                  <a:extLst>
                    <a:ext uri="{9D8B030D-6E8A-4147-A177-3AD203B41FA5}">
                      <a16:colId xmlns:a16="http://schemas.microsoft.com/office/drawing/2014/main" val="61429748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</a:rPr>
                        <a:t>Result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Ar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ea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SD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edia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>
                          <a:effectLst/>
                        </a:rPr>
                        <a:t>Min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b="1" dirty="0">
                          <a:effectLst/>
                        </a:rPr>
                        <a:t>Max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842897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Prothrombin time (seconds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3.1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1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3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290024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2.9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5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2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4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338541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Fibrinogen (g/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9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8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5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.3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898994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3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.2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5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8.1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958603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APTT (seconds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6.6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3.5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6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40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875696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NM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9.0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5.6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8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7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62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608854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Protein C (IU/m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So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3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2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3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6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8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309539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2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3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2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7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7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937291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Antithrombin (IU/ml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SoC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1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2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0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7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2.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411795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N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2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1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1.2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>
                          <a:effectLst/>
                        </a:rPr>
                        <a:t>0.8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effectLst/>
                        </a:rPr>
                        <a:t>1.6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426626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E3A725A-F14A-C344-9328-6BE2BC298103}"/>
              </a:ext>
            </a:extLst>
          </p:cNvPr>
          <p:cNvSpPr txBox="1"/>
          <p:nvPr/>
        </p:nvSpPr>
        <p:spPr>
          <a:xfrm>
            <a:off x="502024" y="4607859"/>
            <a:ext cx="1111623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Table 5: </a:t>
            </a:r>
            <a:r>
              <a:rPr lang="en-GB" dirty="0"/>
              <a:t>Summary clinical  safety haematological and biochemical blood results outcome by group- (SoC) standard of care versus IV NM. Blood results checked daily for all patients during their time in the trial. </a:t>
            </a:r>
          </a:p>
          <a:p>
            <a:endParaRPr lang="en-IE" dirty="0"/>
          </a:p>
        </p:txBody>
      </p:sp>
    </p:spTree>
    <p:extLst>
      <p:ext uri="{BB962C8B-B14F-4D97-AF65-F5344CB8AC3E}">
        <p14:creationId xmlns:p14="http://schemas.microsoft.com/office/powerpoint/2010/main" val="245285439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802192B2-CDAB-B043-B443-ED179C122B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2439631"/>
              </p:ext>
            </p:extLst>
          </p:nvPr>
        </p:nvGraphicFramePr>
        <p:xfrm>
          <a:off x="1057820" y="115475"/>
          <a:ext cx="5067660" cy="6623873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266915">
                  <a:extLst>
                    <a:ext uri="{9D8B030D-6E8A-4147-A177-3AD203B41FA5}">
                      <a16:colId xmlns:a16="http://schemas.microsoft.com/office/drawing/2014/main" val="511665144"/>
                    </a:ext>
                  </a:extLst>
                </a:gridCol>
                <a:gridCol w="1266915">
                  <a:extLst>
                    <a:ext uri="{9D8B030D-6E8A-4147-A177-3AD203B41FA5}">
                      <a16:colId xmlns:a16="http://schemas.microsoft.com/office/drawing/2014/main" val="3729448617"/>
                    </a:ext>
                  </a:extLst>
                </a:gridCol>
                <a:gridCol w="1266915">
                  <a:extLst>
                    <a:ext uri="{9D8B030D-6E8A-4147-A177-3AD203B41FA5}">
                      <a16:colId xmlns:a16="http://schemas.microsoft.com/office/drawing/2014/main" val="2866999305"/>
                    </a:ext>
                  </a:extLst>
                </a:gridCol>
                <a:gridCol w="1266915">
                  <a:extLst>
                    <a:ext uri="{9D8B030D-6E8A-4147-A177-3AD203B41FA5}">
                      <a16:colId xmlns:a16="http://schemas.microsoft.com/office/drawing/2014/main" val="2063323109"/>
                    </a:ext>
                  </a:extLst>
                </a:gridCol>
              </a:tblGrid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 HPD Interval Lower limi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 HPD Interval Upper limi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84289787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aemoglobin (g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26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2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7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29002415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aematocrit (ratio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.27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6.1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83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33854173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d cell count (109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.08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6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853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89899476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an cell volume (fl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.53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6.2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50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95860385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an Cell Hb (pg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2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5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587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87569601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an Cell Hb Conc (g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81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0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0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60885470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hite Cell Count (109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02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.8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59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30953980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utrophil Count (109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00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.6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41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93729103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ymphocytes (109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9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4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46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41179549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nocyte Count (109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34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7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67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4266266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asophil Count (109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7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1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423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63559284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osinophil Count (109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48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9.1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.77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92962939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latelet Count (109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59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8.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1.32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42615148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ndom Glucose (micromole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22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3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03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0397849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rea (mmol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41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9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03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73514393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dium (mmol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.2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7.9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32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94056639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tassium (mmol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31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0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48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13959676"/>
                  </a:ext>
                </a:extLst>
              </a:tr>
              <a:tr h="26659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loride (mmol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1.3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7.2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78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34168757"/>
                  </a:ext>
                </a:extLst>
              </a:tr>
            </a:tbl>
          </a:graphicData>
        </a:graphic>
      </p:graphicFrame>
      <p:graphicFrame>
        <p:nvGraphicFramePr>
          <p:cNvPr id="4" name="Table 2">
            <a:extLst>
              <a:ext uri="{FF2B5EF4-FFF2-40B4-BE49-F238E27FC236}">
                <a16:creationId xmlns:a16="http://schemas.microsoft.com/office/drawing/2014/main" id="{802192B2-CDAB-B043-B443-ED179C122B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1034105"/>
              </p:ext>
            </p:extLst>
          </p:nvPr>
        </p:nvGraphicFramePr>
        <p:xfrm>
          <a:off x="6182885" y="115474"/>
          <a:ext cx="5067660" cy="6623869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266915">
                  <a:extLst>
                    <a:ext uri="{9D8B030D-6E8A-4147-A177-3AD203B41FA5}">
                      <a16:colId xmlns:a16="http://schemas.microsoft.com/office/drawing/2014/main" val="511665144"/>
                    </a:ext>
                  </a:extLst>
                </a:gridCol>
                <a:gridCol w="1266915">
                  <a:extLst>
                    <a:ext uri="{9D8B030D-6E8A-4147-A177-3AD203B41FA5}">
                      <a16:colId xmlns:a16="http://schemas.microsoft.com/office/drawing/2014/main" val="3729448617"/>
                    </a:ext>
                  </a:extLst>
                </a:gridCol>
                <a:gridCol w="1266915">
                  <a:extLst>
                    <a:ext uri="{9D8B030D-6E8A-4147-A177-3AD203B41FA5}">
                      <a16:colId xmlns:a16="http://schemas.microsoft.com/office/drawing/2014/main" val="2866999305"/>
                    </a:ext>
                  </a:extLst>
                </a:gridCol>
                <a:gridCol w="1266915">
                  <a:extLst>
                    <a:ext uri="{9D8B030D-6E8A-4147-A177-3AD203B41FA5}">
                      <a16:colId xmlns:a16="http://schemas.microsoft.com/office/drawing/2014/main" val="2063323109"/>
                    </a:ext>
                  </a:extLst>
                </a:gridCol>
              </a:tblGrid>
              <a:tr h="3643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 HPD Interval Lower limi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 HPD Interval Upper limi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84289787"/>
                  </a:ext>
                </a:extLst>
              </a:tr>
              <a:tr h="3643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gnesium (mmol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.38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8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18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29002415"/>
                  </a:ext>
                </a:extLst>
              </a:tr>
              <a:tr h="3643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carbonate (mmol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1.5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7.2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27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33854173"/>
                  </a:ext>
                </a:extLst>
              </a:tr>
              <a:tr h="3643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eatinine (micromole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.5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42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9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89899476"/>
                  </a:ext>
                </a:extLst>
              </a:tr>
              <a:tr h="3438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al Protein (g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9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8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07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95860385"/>
                  </a:ext>
                </a:extLst>
              </a:tr>
              <a:tr h="3438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bumin (g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.07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6.2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95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87569601"/>
                  </a:ext>
                </a:extLst>
              </a:tr>
              <a:tr h="3438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ST (U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.0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2.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5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60885470"/>
                  </a:ext>
                </a:extLst>
              </a:tr>
              <a:tr h="3643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al Bilirubin (micromole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0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6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03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30953980"/>
                  </a:ext>
                </a:extLst>
              </a:tr>
              <a:tr h="3438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T (U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.9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0.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.0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93729103"/>
                  </a:ext>
                </a:extLst>
              </a:tr>
              <a:tr h="3438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T (U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.05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1.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8.8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41179549"/>
                  </a:ext>
                </a:extLst>
              </a:tr>
              <a:tr h="3438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k Phos (U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94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.8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.6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4266266"/>
                  </a:ext>
                </a:extLst>
              </a:tr>
              <a:tr h="3438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DH (U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1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1.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.2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63559284"/>
                  </a:ext>
                </a:extLst>
              </a:tr>
              <a:tr h="3643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rritin (micromole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3.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4.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78.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92962939"/>
                  </a:ext>
                </a:extLst>
              </a:tr>
              <a:tr h="3438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P (mg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13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15.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.5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42615148"/>
                  </a:ext>
                </a:extLst>
              </a:tr>
              <a:tr h="3438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oponin (ng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2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11.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88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0397849"/>
                  </a:ext>
                </a:extLst>
              </a:tr>
              <a:tr h="3643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iglycerides (mmol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6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4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67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73514393"/>
                  </a:ext>
                </a:extLst>
              </a:tr>
              <a:tr h="3438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-Dimer (ng/m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21.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10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22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94056639"/>
                  </a:ext>
                </a:extLst>
              </a:tr>
              <a:tr h="3643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eatinine Kinase (U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18.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74.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8.2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13959676"/>
                  </a:ext>
                </a:extLst>
              </a:tr>
              <a:tr h="27071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R (ratio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2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3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53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34168757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F3E66012-9397-3D44-A911-BFA1CE4DABCB}"/>
              </a:ext>
            </a:extLst>
          </p:cNvPr>
          <p:cNvSpPr/>
          <p:nvPr/>
        </p:nvSpPr>
        <p:spPr>
          <a:xfrm>
            <a:off x="0" y="0"/>
            <a:ext cx="8597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en-GB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3383165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802192B2-CDAB-B043-B443-ED179C122B36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43436" y="115475"/>
          <a:ext cx="5067660" cy="488190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266915">
                  <a:extLst>
                    <a:ext uri="{9D8B030D-6E8A-4147-A177-3AD203B41FA5}">
                      <a16:colId xmlns:a16="http://schemas.microsoft.com/office/drawing/2014/main" val="511665144"/>
                    </a:ext>
                  </a:extLst>
                </a:gridCol>
                <a:gridCol w="1266915">
                  <a:extLst>
                    <a:ext uri="{9D8B030D-6E8A-4147-A177-3AD203B41FA5}">
                      <a16:colId xmlns:a16="http://schemas.microsoft.com/office/drawing/2014/main" val="3729448617"/>
                    </a:ext>
                  </a:extLst>
                </a:gridCol>
                <a:gridCol w="1266915">
                  <a:extLst>
                    <a:ext uri="{9D8B030D-6E8A-4147-A177-3AD203B41FA5}">
                      <a16:colId xmlns:a16="http://schemas.microsoft.com/office/drawing/2014/main" val="2866999305"/>
                    </a:ext>
                  </a:extLst>
                </a:gridCol>
                <a:gridCol w="1266915">
                  <a:extLst>
                    <a:ext uri="{9D8B030D-6E8A-4147-A177-3AD203B41FA5}">
                      <a16:colId xmlns:a16="http://schemas.microsoft.com/office/drawing/2014/main" val="2063323109"/>
                    </a:ext>
                  </a:extLst>
                </a:gridCol>
              </a:tblGrid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a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 HPD Interval Lower limi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 HPD Interval Upper limi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84289787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thrombin time (seconds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6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3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44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29002415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brinogen (g/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4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0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21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33854173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PTT (seconds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04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.9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923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89899476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tein C (IU/m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.03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6.1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83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95860385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tithrombin (IU/ml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.25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6.4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96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87569601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2 Saturation (%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2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8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52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60885470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spiratory Rate (bpm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.14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4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41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30953980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ystolic Blood Pressure (mm Hg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6.2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17.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91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93729103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astolic Blood Pressure (mm Hg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.3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9.4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47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41179549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emperature (degrees C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5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.3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49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4266266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ulse (bpm)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82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7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.34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63559284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CG Rate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.5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11.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47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92962939"/>
                  </a:ext>
                </a:extLst>
              </a:tr>
              <a:tr h="338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CG QTc 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12.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26.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91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426151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1048806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35742" y="786581"/>
            <a:ext cx="106286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Table 6 </a:t>
            </a:r>
            <a:r>
              <a:rPr lang="en-GB" dirty="0"/>
              <a:t>Continuous outcome variable results: haematological and biochemical safety laboratory outcomes and vital signs. </a:t>
            </a:r>
          </a:p>
        </p:txBody>
      </p:sp>
    </p:spTree>
    <p:extLst>
      <p:ext uri="{BB962C8B-B14F-4D97-AF65-F5344CB8AC3E}">
        <p14:creationId xmlns:p14="http://schemas.microsoft.com/office/powerpoint/2010/main" val="3826177372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625757" y="871811"/>
          <a:ext cx="10912132" cy="1850840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462312">
                  <a:extLst>
                    <a:ext uri="{9D8B030D-6E8A-4147-A177-3AD203B41FA5}">
                      <a16:colId xmlns:a16="http://schemas.microsoft.com/office/drawing/2014/main" val="407992547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836591024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72945267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35688510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493139141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714503635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020236901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563999223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768567516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019519070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51085190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488942045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08168760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412573203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47778613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255609961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972147513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121941325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81930362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1109519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90386419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18479523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84557420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62360596"/>
                    </a:ext>
                  </a:extLst>
                </a:gridCol>
              </a:tblGrid>
              <a:tr h="462710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gridSpan="12"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smtClean="0">
                          <a:effectLst/>
                        </a:rPr>
                        <a:t>E gene </a:t>
                      </a:r>
                      <a:r>
                        <a:rPr lang="en-GB" sz="1200" u="none" strike="noStrike" dirty="0" err="1" smtClean="0">
                          <a:effectLst/>
                        </a:rPr>
                        <a:t>Nafamostat</a:t>
                      </a:r>
                      <a:r>
                        <a:rPr lang="en-GB" sz="1200" u="none" strike="noStrike" dirty="0" smtClean="0">
                          <a:effectLst/>
                        </a:rPr>
                        <a:t> Nasopharyngeal</a:t>
                      </a:r>
                      <a:r>
                        <a:rPr lang="en-GB" sz="1200" u="none" strike="noStrike" baseline="0" dirty="0" smtClean="0">
                          <a:effectLst/>
                        </a:rPr>
                        <a:t> swab Ct values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11"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smtClean="0">
                          <a:effectLst/>
                        </a:rPr>
                        <a:t>E gene </a:t>
                      </a:r>
                      <a:r>
                        <a:rPr lang="en-GB" sz="1200" u="none" strike="noStrike" dirty="0" err="1" smtClean="0">
                          <a:effectLst/>
                        </a:rPr>
                        <a:t>SoC</a:t>
                      </a:r>
                      <a:r>
                        <a:rPr lang="en-GB" sz="1200" u="none" strike="noStrike" dirty="0" smtClean="0">
                          <a:effectLst/>
                        </a:rPr>
                        <a:t> NT Nasopharyngeal swab Ct values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8365537"/>
                  </a:ext>
                </a:extLst>
              </a:tr>
              <a:tr h="46271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Day 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7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6.3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2.9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2.5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9.4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0.9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3.02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2.25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3.3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7.56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1.2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5.5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9.5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6.3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3.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4.3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9.0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1809061123"/>
                  </a:ext>
                </a:extLst>
              </a:tr>
              <a:tr h="46271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Day 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0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8.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4.2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9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4.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9.5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4.6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2.3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45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6.76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45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9.39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45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1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3.0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4155350379"/>
                  </a:ext>
                </a:extLst>
              </a:tr>
              <a:tr h="46271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Day 5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0.2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2.7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3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1.3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3.35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0.5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19.65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45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1.7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2051841539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/>
          </p:nvPr>
        </p:nvGraphicFramePr>
        <p:xfrm>
          <a:off x="625760" y="3283376"/>
          <a:ext cx="10912129" cy="1833156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462309">
                  <a:extLst>
                    <a:ext uri="{9D8B030D-6E8A-4147-A177-3AD203B41FA5}">
                      <a16:colId xmlns:a16="http://schemas.microsoft.com/office/drawing/2014/main" val="3357068335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654815629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895711069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48070309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32716321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237250392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345209040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11608368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093859084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734082592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903386345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846734551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68206293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54179239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359498510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92246099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42293348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831042256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85953084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81284413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81332192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531417276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988221781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4050287860"/>
                    </a:ext>
                  </a:extLst>
                </a:gridCol>
              </a:tblGrid>
              <a:tr h="458289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gridSpan="12"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smtClean="0">
                          <a:effectLst/>
                        </a:rPr>
                        <a:t>S gene </a:t>
                      </a:r>
                      <a:r>
                        <a:rPr lang="en-GB" sz="1200" u="none" strike="noStrike" dirty="0" err="1" smtClean="0">
                          <a:effectLst/>
                        </a:rPr>
                        <a:t>Nafamostat</a:t>
                      </a:r>
                      <a:r>
                        <a:rPr lang="en-GB" sz="1200" u="none" strike="noStrike" dirty="0" smtClean="0">
                          <a:effectLst/>
                        </a:rPr>
                        <a:t> Nasopharyngeal</a:t>
                      </a:r>
                      <a:r>
                        <a:rPr lang="en-GB" sz="1200" u="none" strike="noStrike" baseline="0" dirty="0" smtClean="0">
                          <a:effectLst/>
                        </a:rPr>
                        <a:t> swab </a:t>
                      </a:r>
                      <a:r>
                        <a:rPr lang="en-GB" sz="1200" u="none" strike="noStrike" dirty="0" smtClean="0">
                          <a:effectLst/>
                        </a:rPr>
                        <a:t>Ct values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11"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smtClean="0">
                          <a:effectLst/>
                        </a:rPr>
                        <a:t>S gene SOC Nasopharyngeal swab Ct values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252450"/>
                  </a:ext>
                </a:extLst>
              </a:tr>
              <a:tr h="45828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Day 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8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6.5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2.3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1.9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8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0.0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2.2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1.2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3.2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6.5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1.5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4.9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5.8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8.5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2.6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3.3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4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973022988"/>
                  </a:ext>
                </a:extLst>
              </a:tr>
              <a:tr h="45828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Day 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9.5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9.5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3.6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6.2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3.69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7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7.5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2.3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6.7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9.3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1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3.0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3822827309"/>
                  </a:ext>
                </a:extLst>
              </a:tr>
              <a:tr h="45828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Day 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0.2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2.7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3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1.3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3.3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 smtClean="0">
                          <a:effectLst/>
                          <a:latin typeface="+mn-lt"/>
                        </a:rPr>
                        <a:t>45</a:t>
                      </a:r>
                      <a:endParaRPr lang="en-GB" sz="1200" b="0" i="0" u="none" strike="noStrike" dirty="0">
                        <a:effectLst/>
                        <a:latin typeface="+mn-lt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3.45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0.54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9.6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45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1.7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2696571840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F3E66012-9397-3D44-A911-BFA1CE4DABCB}"/>
              </a:ext>
            </a:extLst>
          </p:cNvPr>
          <p:cNvSpPr/>
          <p:nvPr/>
        </p:nvSpPr>
        <p:spPr>
          <a:xfrm>
            <a:off x="0" y="0"/>
            <a:ext cx="8597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en-GB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25997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84D4C91-BDAC-DD46-8089-59973161BEB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218493" y="129150"/>
          <a:ext cx="8728364" cy="7062988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7297207">
                  <a:extLst>
                    <a:ext uri="{9D8B030D-6E8A-4147-A177-3AD203B41FA5}">
                      <a16:colId xmlns:a16="http://schemas.microsoft.com/office/drawing/2014/main" val="1690574720"/>
                    </a:ext>
                  </a:extLst>
                </a:gridCol>
                <a:gridCol w="1431157">
                  <a:extLst>
                    <a:ext uri="{9D8B030D-6E8A-4147-A177-3AD203B41FA5}">
                      <a16:colId xmlns:a16="http://schemas.microsoft.com/office/drawing/2014/main" val="3903171770"/>
                    </a:ext>
                  </a:extLst>
                </a:gridCol>
              </a:tblGrid>
              <a:tr h="27799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Blood sampling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</a:rPr>
                        <a:t>Frequency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3233611966"/>
                  </a:ext>
                </a:extLst>
              </a:tr>
              <a:tr h="27799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i="1" dirty="0">
                          <a:effectLst/>
                        </a:rPr>
                        <a:t>FBC, differential WCC (excluding eosinophils), platelets</a:t>
                      </a:r>
                      <a:endParaRPr lang="en-GB" sz="14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Daily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775112324"/>
                  </a:ext>
                </a:extLst>
              </a:tr>
              <a:tr h="924464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i="1" dirty="0">
                          <a:effectLst/>
                        </a:rPr>
                        <a:t>Urea, creatinine, sodium, potassium, bicarbonate, chloride, magnesium, calcium, bilirubin , ALT, AST, Alkaline phosphatase, GGT, total protein, albumin, CRP, ferritin, triglycerides, troponin, creatinine kinase</a:t>
                      </a:r>
                      <a:endParaRPr lang="en-GB" sz="14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Daily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577249256"/>
                  </a:ext>
                </a:extLst>
              </a:tr>
              <a:tr h="601228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i="1" dirty="0">
                          <a:effectLst/>
                        </a:rPr>
                        <a:t>Activated partial thromboplastin time (APTT), Prothrombin time (PT), INR, fibrinogen, D-dimer,</a:t>
                      </a:r>
                      <a:endParaRPr lang="en-GB" sz="14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Daily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2740359999"/>
                  </a:ext>
                </a:extLst>
              </a:tr>
              <a:tr h="27799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 err="1">
                          <a:effectLst/>
                        </a:rPr>
                        <a:t>Thromboelastography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Daily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688813014"/>
                  </a:ext>
                </a:extLst>
              </a:tr>
              <a:tr h="27799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i="1" dirty="0">
                          <a:effectLst/>
                        </a:rPr>
                        <a:t>Glucose and/or capillary blood glucose</a:t>
                      </a:r>
                      <a:endParaRPr lang="en-GB" sz="14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Daily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2559025622"/>
                  </a:ext>
                </a:extLst>
              </a:tr>
              <a:tr h="277992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Biomarkers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Daily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3267689786"/>
                  </a:ext>
                </a:extLst>
              </a:tr>
              <a:tr h="601228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Immune phenotyping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Baseline, D4 and D7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222607782"/>
                  </a:ext>
                </a:extLst>
              </a:tr>
              <a:tr h="277992">
                <a:tc gridSpan="2"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Virology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2516825088"/>
                  </a:ext>
                </a:extLst>
              </a:tr>
              <a:tr h="601228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Oropharyngeal/nasopharyngeal swab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1, 3, 5, 8, 11, 15 (±1 day)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2600018123"/>
                  </a:ext>
                </a:extLst>
              </a:tr>
              <a:tr h="601228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>
                          <a:effectLst/>
                        </a:rPr>
                        <a:t>Saliva</a:t>
                      </a:r>
                      <a:endParaRPr lang="en-GB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400" dirty="0">
                          <a:effectLst/>
                        </a:rPr>
                        <a:t>1, 3, 5, 8, 11, 15 (±1 day)</a:t>
                      </a:r>
                      <a:endParaRPr lang="en-GB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6532" marR="36532" marT="0" marB="0"/>
                </a:tc>
                <a:extLst>
                  <a:ext uri="{0D108BD9-81ED-4DB2-BD59-A6C34878D82A}">
                    <a16:rowId xmlns:a16="http://schemas.microsoft.com/office/drawing/2014/main" val="10965885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6380009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/>
          </p:nvPr>
        </p:nvGraphicFramePr>
        <p:xfrm>
          <a:off x="673803" y="3315821"/>
          <a:ext cx="10915446" cy="1790436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462452">
                  <a:extLst>
                    <a:ext uri="{9D8B030D-6E8A-4147-A177-3AD203B41FA5}">
                      <a16:colId xmlns:a16="http://schemas.microsoft.com/office/drawing/2014/main" val="1850116317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1255607750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2787336479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3948501568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538660717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509856529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534356122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2553390165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3897531612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2956457993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2847616713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2238509405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1706601487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4146632806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3127834901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194516392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392713476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916463812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641047241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569886877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1492133219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447443015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3511054070"/>
                    </a:ext>
                  </a:extLst>
                </a:gridCol>
                <a:gridCol w="454478">
                  <a:extLst>
                    <a:ext uri="{9D8B030D-6E8A-4147-A177-3AD203B41FA5}">
                      <a16:colId xmlns:a16="http://schemas.microsoft.com/office/drawing/2014/main" val="1924045879"/>
                    </a:ext>
                  </a:extLst>
                </a:gridCol>
              </a:tblGrid>
              <a:tr h="447609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gridSpan="12"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S gene </a:t>
                      </a:r>
                      <a:r>
                        <a:rPr lang="en-GB" sz="1200" u="none" strike="noStrike" dirty="0" err="1">
                          <a:effectLst/>
                        </a:rPr>
                        <a:t>Nafamostat</a:t>
                      </a:r>
                      <a:r>
                        <a:rPr lang="en-GB" sz="1200" u="none" strike="noStrike" dirty="0">
                          <a:effectLst/>
                        </a:rPr>
                        <a:t> </a:t>
                      </a:r>
                      <a:r>
                        <a:rPr lang="en-GB" sz="1200" u="none" strike="noStrike" dirty="0" smtClean="0">
                          <a:effectLst/>
                        </a:rPr>
                        <a:t>saliva Ct values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11"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S gene </a:t>
                      </a:r>
                      <a:r>
                        <a:rPr lang="en-GB" sz="1200" u="none" strike="noStrike" dirty="0" err="1">
                          <a:effectLst/>
                        </a:rPr>
                        <a:t>SoC</a:t>
                      </a:r>
                      <a:r>
                        <a:rPr lang="en-GB" sz="1200" u="none" strike="noStrike" dirty="0">
                          <a:effectLst/>
                        </a:rPr>
                        <a:t> </a:t>
                      </a:r>
                      <a:r>
                        <a:rPr lang="en-GB" sz="1200" u="none" strike="noStrike" dirty="0" smtClean="0">
                          <a:effectLst/>
                        </a:rPr>
                        <a:t>saliva Ct values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86223634"/>
                  </a:ext>
                </a:extLst>
              </a:tr>
              <a:tr h="44760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Day 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9.5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6.5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2.8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9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0.8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1.8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33.67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8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3.7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7.7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1.7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5.7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9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5.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4.8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5.6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9.8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1325333723"/>
                  </a:ext>
                </a:extLst>
              </a:tr>
              <a:tr h="44760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Day 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9.7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4.4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4.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6.7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4.8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4.3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9.1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4.7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1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8.8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6.7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3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0.8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4232609397"/>
                  </a:ext>
                </a:extLst>
              </a:tr>
              <a:tr h="44760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Day 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1.56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6.4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8.6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7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5.8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0.89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5.4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5.5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0.5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1770732711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/>
          </p:nvPr>
        </p:nvGraphicFramePr>
        <p:xfrm>
          <a:off x="673803" y="990615"/>
          <a:ext cx="10912132" cy="1783404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462312">
                  <a:extLst>
                    <a:ext uri="{9D8B030D-6E8A-4147-A177-3AD203B41FA5}">
                      <a16:colId xmlns:a16="http://schemas.microsoft.com/office/drawing/2014/main" val="2998683446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683317225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221438132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70369940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251971153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442015383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625876895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802265006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14219144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149546866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559916205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97156225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43764478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19959333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807080881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1226655174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619955411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800255804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08651643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3994692354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971504350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849860227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2580392808"/>
                    </a:ext>
                  </a:extLst>
                </a:gridCol>
                <a:gridCol w="454340">
                  <a:extLst>
                    <a:ext uri="{9D8B030D-6E8A-4147-A177-3AD203B41FA5}">
                      <a16:colId xmlns:a16="http://schemas.microsoft.com/office/drawing/2014/main" val="73410057"/>
                    </a:ext>
                  </a:extLst>
                </a:gridCol>
              </a:tblGrid>
              <a:tr h="445851"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gridSpan="12"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smtClean="0">
                          <a:effectLst/>
                        </a:rPr>
                        <a:t>E gene </a:t>
                      </a:r>
                      <a:r>
                        <a:rPr lang="en-GB" sz="1200" u="none" strike="noStrike" dirty="0" err="1" smtClean="0">
                          <a:effectLst/>
                        </a:rPr>
                        <a:t>Nafamostat</a:t>
                      </a:r>
                      <a:r>
                        <a:rPr lang="en-GB" sz="1200" u="none" strike="noStrike" dirty="0" smtClean="0">
                          <a:effectLst/>
                        </a:rPr>
                        <a:t> saliva Ct values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11"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 smtClean="0">
                          <a:effectLst/>
                        </a:rPr>
                        <a:t>E gene </a:t>
                      </a:r>
                      <a:r>
                        <a:rPr lang="en-GB" sz="1200" u="none" strike="noStrike" dirty="0" err="1" smtClean="0">
                          <a:effectLst/>
                        </a:rPr>
                        <a:t>SoC</a:t>
                      </a:r>
                      <a:r>
                        <a:rPr lang="en-GB" sz="1200" u="none" strike="noStrike" dirty="0" smtClean="0">
                          <a:effectLst/>
                        </a:rPr>
                        <a:t> saliva Ct values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58600497"/>
                  </a:ext>
                </a:extLst>
              </a:tr>
              <a:tr h="44585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Day 1 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9.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7.6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1.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0.2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1.1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5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2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3.6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5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2.4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5.3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9.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5.77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4.4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4.78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9.5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4016638905"/>
                  </a:ext>
                </a:extLst>
              </a:tr>
              <a:tr h="44585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Day 3 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0.4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5.4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2.3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5.6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4.4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4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8.4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4.5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2.5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45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19.3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6.5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7.1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1846961938"/>
                  </a:ext>
                </a:extLst>
              </a:tr>
              <a:tr h="44585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Day 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2.43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7.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7.6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3.56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5.44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0.33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25.66</a:t>
                      </a:r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5.2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0.31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29.45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</a:rPr>
                        <a:t>30.12</a:t>
                      </a:r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2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46" marR="3846" marT="3846" marB="0" anchor="b"/>
                </a:tc>
                <a:extLst>
                  <a:ext uri="{0D108BD9-81ED-4DB2-BD59-A6C34878D82A}">
                    <a16:rowId xmlns:a16="http://schemas.microsoft.com/office/drawing/2014/main" val="16298005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68061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65079" y="441789"/>
            <a:ext cx="10983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7 </a:t>
            </a:r>
            <a:r>
              <a:rPr lang="en-GB" dirty="0" smtClean="0"/>
              <a:t>Altona RT-PCR Ct valu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940723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2392236" y="551175"/>
          <a:ext cx="2313327" cy="2859849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1248463">
                  <a:extLst>
                    <a:ext uri="{9D8B030D-6E8A-4147-A177-3AD203B41FA5}">
                      <a16:colId xmlns:a16="http://schemas.microsoft.com/office/drawing/2014/main" val="2837098269"/>
                    </a:ext>
                  </a:extLst>
                </a:gridCol>
                <a:gridCol w="1064864">
                  <a:extLst>
                    <a:ext uri="{9D8B030D-6E8A-4147-A177-3AD203B41FA5}">
                      <a16:colId xmlns:a16="http://schemas.microsoft.com/office/drawing/2014/main" val="2866447548"/>
                    </a:ext>
                  </a:extLst>
                </a:gridCol>
              </a:tblGrid>
              <a:tr h="317761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Altona E</a:t>
                      </a:r>
                      <a:endParaRPr lang="en-GB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1415960"/>
                  </a:ext>
                </a:extLst>
              </a:tr>
              <a:tr h="31776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copies/mL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Ct value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10944994"/>
                  </a:ext>
                </a:extLst>
              </a:tr>
              <a:tr h="317761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300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1.45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31011901"/>
                  </a:ext>
                </a:extLst>
              </a:tr>
              <a:tr h="317761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640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0.91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0812890"/>
                  </a:ext>
                </a:extLst>
              </a:tr>
              <a:tr h="317761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30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3.45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861889657"/>
                  </a:ext>
                </a:extLst>
              </a:tr>
              <a:tr h="317761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030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2.2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867885083"/>
                  </a:ext>
                </a:extLst>
              </a:tr>
              <a:tr h="317761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3001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1.5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8321153"/>
                  </a:ext>
                </a:extLst>
              </a:tr>
              <a:tr h="317761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3000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8.24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863795385"/>
                  </a:ext>
                </a:extLst>
              </a:tr>
              <a:tr h="317761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3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36.36</a:t>
                      </a:r>
                      <a:endParaRPr lang="en-GB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85417181"/>
                  </a:ext>
                </a:extLst>
              </a:tr>
            </a:tbl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6356350" y="636998"/>
          <a:ext cx="3398838" cy="58562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Prism 9" r:id="rId3" imgW="5859048" imgH="9334222" progId="Prism9.Document">
                  <p:embed/>
                </p:oleObj>
              </mc:Choice>
              <mc:Fallback>
                <p:oleObj name="Prism 9" r:id="rId3" imgW="5859048" imgH="9334222" progId="Prism9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56350" y="636998"/>
                        <a:ext cx="3398838" cy="58562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2392236" y="3632590"/>
          <a:ext cx="2313327" cy="2860677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1498155">
                  <a:extLst>
                    <a:ext uri="{9D8B030D-6E8A-4147-A177-3AD203B41FA5}">
                      <a16:colId xmlns:a16="http://schemas.microsoft.com/office/drawing/2014/main" val="2609936043"/>
                    </a:ext>
                  </a:extLst>
                </a:gridCol>
                <a:gridCol w="815172">
                  <a:extLst>
                    <a:ext uri="{9D8B030D-6E8A-4147-A177-3AD203B41FA5}">
                      <a16:colId xmlns:a16="http://schemas.microsoft.com/office/drawing/2014/main" val="604365988"/>
                    </a:ext>
                  </a:extLst>
                </a:gridCol>
              </a:tblGrid>
              <a:tr h="31785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Altona S</a:t>
                      </a:r>
                      <a:endParaRPr lang="en-GB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r" fontAlgn="b"/>
                      <a:endParaRPr lang="en-GB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6560195"/>
                  </a:ext>
                </a:extLst>
              </a:tr>
              <a:tr h="317853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Copies/mL</a:t>
                      </a:r>
                      <a:endParaRPr lang="en-GB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</a:rPr>
                        <a:t>Ct value</a:t>
                      </a:r>
                      <a:endParaRPr lang="en-GB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63155335"/>
                  </a:ext>
                </a:extLst>
              </a:tr>
              <a:tr h="317853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300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1.81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095205891"/>
                  </a:ext>
                </a:extLst>
              </a:tr>
              <a:tr h="317853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640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1.1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78905964"/>
                  </a:ext>
                </a:extLst>
              </a:tr>
              <a:tr h="317853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30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2.9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7003937"/>
                  </a:ext>
                </a:extLst>
              </a:tr>
              <a:tr h="317853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030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2.41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783454587"/>
                  </a:ext>
                </a:extLst>
              </a:tr>
              <a:tr h="317853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300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1.76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39474917"/>
                  </a:ext>
                </a:extLst>
              </a:tr>
              <a:tr h="317853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3000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8.5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33479092"/>
                  </a:ext>
                </a:extLst>
              </a:tr>
              <a:tr h="317853"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30</a:t>
                      </a:r>
                      <a:endParaRPr lang="en-GB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35.25</a:t>
                      </a:r>
                      <a:endParaRPr lang="en-GB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61728574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F3E66012-9397-3D44-A911-BFA1CE4DABCB}"/>
              </a:ext>
            </a:extLst>
          </p:cNvPr>
          <p:cNvSpPr/>
          <p:nvPr/>
        </p:nvSpPr>
        <p:spPr>
          <a:xfrm>
            <a:off x="498762" y="237511"/>
            <a:ext cx="11134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10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939834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28773" y="441789"/>
            <a:ext cx="10983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Figure </a:t>
            </a:r>
            <a:r>
              <a:rPr lang="en-GB" b="1" dirty="0" smtClean="0"/>
              <a:t>10 </a:t>
            </a:r>
            <a:r>
              <a:rPr lang="en-GB" dirty="0" smtClean="0"/>
              <a:t>QMCD linear panel. Altona Ct to copies/mL conversion with linear regression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349372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08EBDA9-74C4-1B44-8E92-FCC0C648E3B1}"/>
              </a:ext>
            </a:extLst>
          </p:cNvPr>
          <p:cNvSpPr/>
          <p:nvPr/>
        </p:nvSpPr>
        <p:spPr>
          <a:xfrm>
            <a:off x="2356230" y="887824"/>
            <a:ext cx="6787770" cy="1429622"/>
          </a:xfrm>
          <a:prstGeom prst="rect">
            <a:avLst/>
          </a:prstGeom>
          <a:ln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GB" sz="2000" b="1" dirty="0">
                <a:ea typeface="Calibri" panose="020F0502020204030204" pitchFamily="34" charset="0"/>
                <a:cs typeface="Arial" panose="020B0604020202020204" pitchFamily="34" charset="0"/>
              </a:rPr>
              <a:t>Table 3:</a:t>
            </a:r>
            <a:r>
              <a:rPr lang="en-GB" sz="2000" dirty="0">
                <a:ea typeface="Calibri" panose="020F0502020204030204" pitchFamily="34" charset="0"/>
                <a:cs typeface="Arial" panose="020B0604020202020204" pitchFamily="34" charset="0"/>
              </a:rPr>
              <a:t> Daily assessments and blood samples. Safety bloods in </a:t>
            </a:r>
            <a:r>
              <a:rPr lang="en-GB" sz="2000" i="1" dirty="0">
                <a:ea typeface="Calibri" panose="020F0502020204030204" pitchFamily="34" charset="0"/>
                <a:cs typeface="Arial" panose="020B0604020202020204" pitchFamily="34" charset="0"/>
              </a:rPr>
              <a:t>italic</a:t>
            </a:r>
            <a:r>
              <a:rPr lang="en-GB" sz="2000" dirty="0">
                <a:ea typeface="Calibri" panose="020F0502020204030204" pitchFamily="34" charset="0"/>
                <a:cs typeface="Arial" panose="020B0604020202020204" pitchFamily="34" charset="0"/>
              </a:rPr>
              <a:t>. Virology sampling collected from the last 10 participants in each cohort.</a:t>
            </a:r>
          </a:p>
        </p:txBody>
      </p:sp>
    </p:spTree>
    <p:extLst>
      <p:ext uri="{BB962C8B-B14F-4D97-AF65-F5344CB8AC3E}">
        <p14:creationId xmlns:p14="http://schemas.microsoft.com/office/powerpoint/2010/main" val="4653691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Content Placeholder 4" descr="Diagram&#10;&#10;Description automatically generated">
            <a:extLst>
              <a:ext uri="{FF2B5EF4-FFF2-40B4-BE49-F238E27FC236}">
                <a16:creationId xmlns:a16="http://schemas.microsoft.com/office/drawing/2014/main" id="{8E827439-F8BA-6D43-B27F-F96632CD540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1827911" y="333663"/>
            <a:ext cx="8800277" cy="6334683"/>
          </a:xfrm>
        </p:spPr>
      </p:pic>
      <p:sp>
        <p:nvSpPr>
          <p:cNvPr id="39" name="Rectangle 38">
            <a:extLst>
              <a:ext uri="{FF2B5EF4-FFF2-40B4-BE49-F238E27FC236}">
                <a16:creationId xmlns:a16="http://schemas.microsoft.com/office/drawing/2014/main" id="{2CAD2E2E-2FEE-5E4F-AEAD-460E94B4AE2E}"/>
              </a:ext>
            </a:extLst>
          </p:cNvPr>
          <p:cNvSpPr/>
          <p:nvPr/>
        </p:nvSpPr>
        <p:spPr>
          <a:xfrm>
            <a:off x="98918" y="230545"/>
            <a:ext cx="9435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GB" b="1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8</a:t>
            </a:r>
            <a:endParaRPr lang="en-US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D8DC8DE-3E12-084B-81D4-2B6BCF5B593E}"/>
              </a:ext>
            </a:extLst>
          </p:cNvPr>
          <p:cNvSpPr txBox="1"/>
          <p:nvPr/>
        </p:nvSpPr>
        <p:spPr>
          <a:xfrm>
            <a:off x="1383857" y="2804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71E48E2-C7CF-D142-A0B1-C8B35822E02C}"/>
              </a:ext>
            </a:extLst>
          </p:cNvPr>
          <p:cNvSpPr txBox="1"/>
          <p:nvPr/>
        </p:nvSpPr>
        <p:spPr>
          <a:xfrm>
            <a:off x="1383857" y="2804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794EC40-A2A7-CA44-BE3B-19A392C39B1A}"/>
              </a:ext>
            </a:extLst>
          </p:cNvPr>
          <p:cNvSpPr txBox="1"/>
          <p:nvPr/>
        </p:nvSpPr>
        <p:spPr>
          <a:xfrm>
            <a:off x="3711067" y="2921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C7471ED-94BF-A34E-8471-EF5A8F112912}"/>
              </a:ext>
            </a:extLst>
          </p:cNvPr>
          <p:cNvSpPr txBox="1"/>
          <p:nvPr/>
        </p:nvSpPr>
        <p:spPr>
          <a:xfrm>
            <a:off x="5920311" y="330572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7B1AAD8-5C62-6642-8186-FCF1E89742DF}"/>
              </a:ext>
            </a:extLst>
          </p:cNvPr>
          <p:cNvSpPr txBox="1"/>
          <p:nvPr/>
        </p:nvSpPr>
        <p:spPr>
          <a:xfrm>
            <a:off x="8145980" y="343210"/>
            <a:ext cx="8417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EB9CE40-2514-8347-88E8-E289FDC4C7D4}"/>
              </a:ext>
            </a:extLst>
          </p:cNvPr>
          <p:cNvSpPr txBox="1"/>
          <p:nvPr/>
        </p:nvSpPr>
        <p:spPr>
          <a:xfrm>
            <a:off x="1426033" y="182959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B028A63-5116-8343-8B3D-19E76A01499B}"/>
              </a:ext>
            </a:extLst>
          </p:cNvPr>
          <p:cNvSpPr txBox="1"/>
          <p:nvPr/>
        </p:nvSpPr>
        <p:spPr>
          <a:xfrm>
            <a:off x="3707768" y="184209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02525AB-C909-6B4A-8864-D20DF56ECFF2}"/>
              </a:ext>
            </a:extLst>
          </p:cNvPr>
          <p:cNvSpPr txBox="1"/>
          <p:nvPr/>
        </p:nvSpPr>
        <p:spPr>
          <a:xfrm>
            <a:off x="5923069" y="1842098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163BCDA-62F0-E441-A764-A8D1997D9E67}"/>
              </a:ext>
            </a:extLst>
          </p:cNvPr>
          <p:cNvSpPr txBox="1"/>
          <p:nvPr/>
        </p:nvSpPr>
        <p:spPr>
          <a:xfrm>
            <a:off x="8176843" y="18031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6E9E43E-D775-4147-B6DF-2E8E0299DCBE}"/>
              </a:ext>
            </a:extLst>
          </p:cNvPr>
          <p:cNvSpPr txBox="1"/>
          <p:nvPr/>
        </p:nvSpPr>
        <p:spPr>
          <a:xfrm>
            <a:off x="1481459" y="3456058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59C9188-05F2-404D-9286-F564DAFD02B8}"/>
              </a:ext>
            </a:extLst>
          </p:cNvPr>
          <p:cNvSpPr txBox="1"/>
          <p:nvPr/>
        </p:nvSpPr>
        <p:spPr>
          <a:xfrm>
            <a:off x="3818595" y="347576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52E4794-3ED4-254B-AF33-F501C2B7E44C}"/>
              </a:ext>
            </a:extLst>
          </p:cNvPr>
          <p:cNvSpPr txBox="1"/>
          <p:nvPr/>
        </p:nvSpPr>
        <p:spPr>
          <a:xfrm>
            <a:off x="5904917" y="34939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EFE320D-6CBA-5441-B99A-066F6C6BF36F}"/>
              </a:ext>
            </a:extLst>
          </p:cNvPr>
          <p:cNvSpPr txBox="1"/>
          <p:nvPr/>
        </p:nvSpPr>
        <p:spPr>
          <a:xfrm>
            <a:off x="8277631" y="345061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1654C3B-E3F8-9346-B02F-B3A3D5C9A3BA}"/>
              </a:ext>
            </a:extLst>
          </p:cNvPr>
          <p:cNvSpPr txBox="1"/>
          <p:nvPr/>
        </p:nvSpPr>
        <p:spPr>
          <a:xfrm>
            <a:off x="1536894" y="4983813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6C70500-91F0-1746-8843-4A015351E7C0}"/>
              </a:ext>
            </a:extLst>
          </p:cNvPr>
          <p:cNvSpPr txBox="1"/>
          <p:nvPr/>
        </p:nvSpPr>
        <p:spPr>
          <a:xfrm>
            <a:off x="3837996" y="496775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B8269DF-FD38-244C-9AC3-C25F791BFF53}"/>
              </a:ext>
            </a:extLst>
          </p:cNvPr>
          <p:cNvSpPr txBox="1"/>
          <p:nvPr/>
        </p:nvSpPr>
        <p:spPr>
          <a:xfrm>
            <a:off x="5961706" y="4909682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F33E28C-3058-4044-82F4-2A6E9C99C24E}"/>
              </a:ext>
            </a:extLst>
          </p:cNvPr>
          <p:cNvSpPr txBox="1"/>
          <p:nvPr/>
        </p:nvSpPr>
        <p:spPr>
          <a:xfrm>
            <a:off x="8391169" y="499905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</p:spTree>
    <p:extLst>
      <p:ext uri="{BB962C8B-B14F-4D97-AF65-F5344CB8AC3E}">
        <p14:creationId xmlns:p14="http://schemas.microsoft.com/office/powerpoint/2010/main" val="32683360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D4207B7-CC5E-0843-9F89-B56423FADB63}"/>
              </a:ext>
            </a:extLst>
          </p:cNvPr>
          <p:cNvSpPr/>
          <p:nvPr/>
        </p:nvSpPr>
        <p:spPr>
          <a:xfrm>
            <a:off x="1214846" y="1031966"/>
            <a:ext cx="10241430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0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GB" sz="2000" b="1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8</a:t>
            </a:r>
            <a:r>
              <a:rPr lang="en-GB" sz="2000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: </a:t>
            </a:r>
            <a:r>
              <a:rPr lang="en-GB" sz="2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Biomarkers over time. </a:t>
            </a:r>
          </a:p>
          <a:p>
            <a:endParaRPr lang="en-GB" sz="20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GB" sz="2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OC (blue)- standard of care. NAF (pink)- </a:t>
            </a:r>
            <a:r>
              <a:rPr lang="en-GB" sz="2000" dirty="0" err="1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Nafamostat</a:t>
            </a:r>
            <a:r>
              <a:rPr lang="en-GB" sz="2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Mesylate</a:t>
            </a:r>
          </a:p>
          <a:p>
            <a:endParaRPr lang="en-GB" sz="20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GB" sz="20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-G : 	</a:t>
            </a:r>
            <a:r>
              <a:rPr lang="en-GB" sz="2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ynamic changes of COVID-19 cytokine storm related cytokines IL-1β, CCL-2, IL-10, 	TNF⍺, IL-17A, GM-CSF, amphiregulin</a:t>
            </a:r>
          </a:p>
          <a:p>
            <a:endParaRPr lang="en-GB" sz="20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GB" sz="2000" b="1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H-P :</a:t>
            </a:r>
            <a:r>
              <a:rPr lang="en-GB" sz="2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	Key clinical biomarkers troponin, SpO</a:t>
            </a:r>
            <a:r>
              <a:rPr lang="en-GB" sz="2000" baseline="-25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GB" sz="2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/FiO</a:t>
            </a:r>
            <a:r>
              <a:rPr lang="en-GB" sz="2000" baseline="-25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GB" sz="2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ratio, white blood cell count, 	neutrophil count, monocyte count, lymphocyte count, platelets count, PT and ferritin. </a:t>
            </a:r>
          </a:p>
          <a:p>
            <a:endParaRPr lang="en-GB" sz="20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GB" sz="2000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ata presented as mean with best-fit line and 95% confidence intervals by linear regression. GM-CSF data were mostly below the LLOD, however, raw data was used to plot the graph.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3218622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80C6392-EEBF-4247-BD8B-776B4E49330C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8825"/>
          <a:stretch/>
        </p:blipFill>
        <p:spPr>
          <a:xfrm>
            <a:off x="836751" y="109881"/>
            <a:ext cx="6506158" cy="6345381"/>
          </a:xfrm>
          <a:prstGeom prst="rect">
            <a:avLst/>
          </a:prstGeom>
        </p:spPr>
      </p:pic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F8E6B3EF-9C8E-1444-A2E8-1AEAEAD979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1082" y="2732052"/>
            <a:ext cx="5943600" cy="23368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706F3C5-18F5-3F4B-9F81-1EF39747BEF6}"/>
              </a:ext>
            </a:extLst>
          </p:cNvPr>
          <p:cNvSpPr/>
          <p:nvPr/>
        </p:nvSpPr>
        <p:spPr>
          <a:xfrm>
            <a:off x="120656" y="96982"/>
            <a:ext cx="10829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Figure </a:t>
            </a:r>
            <a:r>
              <a:rPr lang="en-GB" b="1" dirty="0" smtClean="0"/>
              <a:t>9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649288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62ED92C-2FC6-B148-9CF9-9EE4189FE0DA}"/>
              </a:ext>
            </a:extLst>
          </p:cNvPr>
          <p:cNvSpPr txBox="1"/>
          <p:nvPr/>
        </p:nvSpPr>
        <p:spPr>
          <a:xfrm>
            <a:off x="1039462" y="1378980"/>
            <a:ext cx="8674485" cy="28315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Figure </a:t>
            </a:r>
            <a:r>
              <a:rPr lang="en-GB" sz="2000" b="1" dirty="0" smtClean="0"/>
              <a:t>9A</a:t>
            </a:r>
            <a:r>
              <a:rPr lang="en-GB" sz="2000" b="1" dirty="0"/>
              <a:t>:</a:t>
            </a:r>
            <a:r>
              <a:rPr lang="en-GB" sz="2000" dirty="0"/>
              <a:t> Gating strategies for T cell subsets. </a:t>
            </a:r>
          </a:p>
          <a:p>
            <a:endParaRPr lang="en-GB" sz="2000" dirty="0"/>
          </a:p>
          <a:p>
            <a:pPr algn="just"/>
            <a:r>
              <a:rPr lang="en-GB" sz="2000" dirty="0"/>
              <a:t>After exclusion of debris and selection of lymphocytes on </a:t>
            </a:r>
            <a:r>
              <a:rPr lang="en-GB" sz="2000" dirty="0" err="1"/>
              <a:t>Fsc</a:t>
            </a:r>
            <a:r>
              <a:rPr lang="en-GB" sz="2000" dirty="0"/>
              <a:t> Vs </a:t>
            </a:r>
            <a:r>
              <a:rPr lang="en-GB" sz="2000" dirty="0" err="1"/>
              <a:t>Ssc</a:t>
            </a:r>
            <a:r>
              <a:rPr lang="en-GB" sz="2000" dirty="0"/>
              <a:t>, doublets were excluded and CD3+ T cells selected. CD4+ and CD8+  T cell subsets were selected and subdivided into naïve versus memory subsets according to expression of CD45RA and CCR7 as shown. </a:t>
            </a:r>
          </a:p>
          <a:p>
            <a:pPr algn="just"/>
            <a:r>
              <a:rPr lang="en-GB" sz="2000" dirty="0"/>
              <a:t>Expression of </a:t>
            </a:r>
            <a:r>
              <a:rPr lang="en-GB" sz="2000" dirty="0" err="1"/>
              <a:t>TCR</a:t>
            </a:r>
            <a:r>
              <a:rPr lang="en-GB" sz="2000" dirty="0" err="1">
                <a:sym typeface="Symbol" pitchFamily="2" charset="2"/>
              </a:rPr>
              <a:t></a:t>
            </a:r>
            <a:r>
              <a:rPr lang="en-GB" sz="2000" dirty="0" err="1">
                <a:latin typeface="Symbol" panose="05050102010706020507" pitchFamily="18" charset="2"/>
              </a:rPr>
              <a:t>d</a:t>
            </a:r>
            <a:r>
              <a:rPr lang="en-GB" sz="2000" dirty="0"/>
              <a:t> on cells expressing CD3 but negative for CD4 and CD8 was used to identify gamma-delta-T cells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650631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8040FB3-269A-2542-8737-A96551E31A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07095" y="2497639"/>
            <a:ext cx="6684905" cy="365505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7F62AF05-A686-C04A-85F2-01D86C7C946A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804"/>
          <a:stretch/>
        </p:blipFill>
        <p:spPr>
          <a:xfrm>
            <a:off x="0" y="443345"/>
            <a:ext cx="6192731" cy="583276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6D2C5FBF-7ABC-7049-9054-486D50905760}"/>
              </a:ext>
            </a:extLst>
          </p:cNvPr>
          <p:cNvSpPr/>
          <p:nvPr/>
        </p:nvSpPr>
        <p:spPr>
          <a:xfrm>
            <a:off x="178017" y="212558"/>
            <a:ext cx="10733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</a:t>
            </a:r>
            <a:r>
              <a:rPr lang="en-GB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7786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2680</Words>
  <Application>Microsoft Office PowerPoint</Application>
  <PresentationFormat>Widescreen</PresentationFormat>
  <Paragraphs>1471</Paragraphs>
  <Slides>33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3</vt:i4>
      </vt:variant>
    </vt:vector>
  </HeadingPairs>
  <TitlesOfParts>
    <vt:vector size="41" baseType="lpstr">
      <vt:lpstr>Arial</vt:lpstr>
      <vt:lpstr>Calibri</vt:lpstr>
      <vt:lpstr>Calibri Light</vt:lpstr>
      <vt:lpstr>DengXian</vt:lpstr>
      <vt:lpstr>Symbol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UGHAN Erin</dc:creator>
  <cp:lastModifiedBy>GAUGHAN Erin</cp:lastModifiedBy>
  <cp:revision>7</cp:revision>
  <dcterms:created xsi:type="dcterms:W3CDTF">2021-10-06T23:22:00Z</dcterms:created>
  <dcterms:modified xsi:type="dcterms:W3CDTF">2021-10-06T23:49:52Z</dcterms:modified>
</cp:coreProperties>
</file>